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>
        <p:scale>
          <a:sx n="214" d="100"/>
          <a:sy n="214" d="100"/>
        </p:scale>
        <p:origin x="672" y="-5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1EF4A3-D6FD-386E-C06F-5A8A9F38F5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759B5B7-93EC-DD34-1CEC-32F7BA5B3A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88006D2-775A-26BB-1F78-D53C85E51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6FBEFCA-C367-6D8A-6D3D-4AF9D2CB7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CA39C2D-2D34-E104-BDA8-DCEE4BB4E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700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D9A4A8-4F12-7D94-96A5-37F67602DE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895433F-F30F-21B4-04C8-9C5286592F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A133C75-BC61-757E-07C7-7F032BE5E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C7C12F4-6DAF-E65D-694E-B517A569C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D6ECA3F-9D4C-F8A3-AE35-8E8E41B27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17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6A532B6-E4FF-7D67-8707-07A5550C08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E5AC511-3C14-B107-DE2B-85A2C585D5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49F1734-FC39-E878-C913-0F1AE928D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C0149E4-2BA6-6CB7-D38F-9F9FEFB61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02A031-4C6F-E48E-357F-242D2BB15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776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FEE759-E59E-2AF3-D4D4-DAAE6464E7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6937CE9-0523-6771-A811-51A843D7B8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87945CE-9891-1C6C-8213-9CDA6BAE4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480074-5E1E-DE7F-EF2F-FC2C1E63F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118412F-D59F-B779-FCA5-72596D80B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132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DC5B8E-8F03-95E6-40D5-1222AF49DB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4AFBD69-AC9E-3FC2-B4D0-BE51E26229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82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82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82F4962-9C78-1A85-9BC6-12AD8509D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377074D-A991-EFD4-651E-3CD83E142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AAD9568-3F07-D8C0-05E0-F7EE9D590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105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82E41C4-1312-E0F5-A429-2E3A77DFED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A73C68A-9722-CB9A-F8D2-9CBB6BB204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7A9296F-CB21-FB8F-82ED-B493E51CD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16B08EF-925F-772D-FF6D-AEF4282B9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2664236-215B-74E1-AAA6-7D2DC11EC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D944C5D-4F16-0260-B856-C820735EE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815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8385A4-A150-98E1-CF3D-5991CB18E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B95A428-E511-FCC8-DF2E-6A0878FD02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0C1226E-97DC-CFD0-CB1C-BA0A9CF55F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363D357-CAB6-C27A-7F08-D421E5EE9E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78490D2-1125-D9F9-9E82-598D26D926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FDA483F-41D6-5146-00B7-69D6B8725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CA76EDD-5957-A412-E9EE-CAAB753FD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6713718B-2300-AFB0-5578-0B26263A5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39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3DA8302-36F1-FA60-0259-194A31DDC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64459DB-3B38-BACB-08A2-0D91E8C62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5BE19F8-25BF-F658-0D03-C8872D48B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CFB87C6-3F8E-5606-B43B-4FA3B1B72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060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FD12000-1C66-401C-01E1-7B28D08D7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4327D85-670C-6EF0-3405-AC250E8DC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F75070E-3D72-5652-C3BE-949F3BADC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04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464000-4A02-0F33-0658-9411E086D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BA9C34E-B2CB-2140-EAB5-4CFB1ACEBB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1433AFD-D9D2-42D8-D9E9-E9F0CF8D15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F6E0128-5C75-F074-D02A-29D150EA6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FE4918D-606E-1F07-2141-06656A41E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FAE2BE3-27F9-4878-A447-4FD8B8482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018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962353-8082-205B-CE70-93320BD37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161828F-2C15-0BE3-5685-9618DDF8B1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F490BF1-0930-DE41-1D42-3CCC0CEBDC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4E4BA14-B748-14A9-6EA9-DE02C6509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99E546C-46A4-9921-4264-C56E8EE91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3D20B70-4AA1-B885-790E-EA437F300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4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1872040-CD78-76C8-63C4-89EDEE4304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EC67E77-2754-0025-1241-97027FC471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553D55A-8DCD-43BF-1930-98ADC2BB36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7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E010CA-1D1D-7640-8EED-AD4E93CD7E91}" type="datetimeFigureOut">
              <a:rPr lang="en-US" smtClean="0"/>
              <a:t>2/16/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1C11337-977C-9253-C222-A29219BC71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6F4FF0E-6E7F-7119-3ECB-0CC089E3B0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606577-6762-3A45-B166-5111398313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19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CuadroTexto 26">
            <a:extLst>
              <a:ext uri="{FF2B5EF4-FFF2-40B4-BE49-F238E27FC236}">
                <a16:creationId xmlns:a16="http://schemas.microsoft.com/office/drawing/2014/main" id="{2227EF5E-B345-44AE-BA9F-E84A2D1A8DC9}"/>
              </a:ext>
            </a:extLst>
          </p:cNvPr>
          <p:cNvSpPr txBox="1"/>
          <p:nvPr/>
        </p:nvSpPr>
        <p:spPr>
          <a:xfrm>
            <a:off x="978031" y="532863"/>
            <a:ext cx="490193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ligonucleotides used in the present study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Tabla 18">
            <a:extLst>
              <a:ext uri="{FF2B5EF4-FFF2-40B4-BE49-F238E27FC236}">
                <a16:creationId xmlns:a16="http://schemas.microsoft.com/office/drawing/2014/main" id="{E8501242-263C-4A06-BF85-272BCFB955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3268899"/>
              </p:ext>
            </p:extLst>
          </p:nvPr>
        </p:nvGraphicFramePr>
        <p:xfrm>
          <a:off x="978031" y="972065"/>
          <a:ext cx="5033914" cy="8401072"/>
        </p:xfrm>
        <a:graphic>
          <a:graphicData uri="http://schemas.openxmlformats.org/drawingml/2006/table">
            <a:tbl>
              <a:tblPr/>
              <a:tblGrid>
                <a:gridCol w="1012487">
                  <a:extLst>
                    <a:ext uri="{9D8B030D-6E8A-4147-A177-3AD203B41FA5}">
                      <a16:colId xmlns:a16="http://schemas.microsoft.com/office/drawing/2014/main" val="2089368029"/>
                    </a:ext>
                  </a:extLst>
                </a:gridCol>
                <a:gridCol w="884144">
                  <a:extLst>
                    <a:ext uri="{9D8B030D-6E8A-4147-A177-3AD203B41FA5}">
                      <a16:colId xmlns:a16="http://schemas.microsoft.com/office/drawing/2014/main" val="1109797810"/>
                    </a:ext>
                  </a:extLst>
                </a:gridCol>
                <a:gridCol w="3137283">
                  <a:extLst>
                    <a:ext uri="{9D8B030D-6E8A-4147-A177-3AD203B41FA5}">
                      <a16:colId xmlns:a16="http://schemas.microsoft.com/office/drawing/2014/main" val="3500654325"/>
                    </a:ext>
                  </a:extLst>
                </a:gridCol>
              </a:tblGrid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a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a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GATCTTTGGATGACTTTGAT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4931977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a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GACGATTAATAAACCCAAAG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3438271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e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e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TGACCTCTGAGAATCCGC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9796808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e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GCCACACAAACTTATAATACCAAA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0699465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f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CTGGATATTTCATTTTACTCCT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4762818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f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AGGGAGATGTGATAGATTCA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3835345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b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B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TGGCCAATTTGTGTACGT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7881665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B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CCACCAAATGTGTTCTCTC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8451478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c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C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GAGTGCCGAAAAGGCTAT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7959632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C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CCAAACCAAAGGTGTTCTC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504816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d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D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TTGACTGTTGGCCAGTTT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8303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D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ACCCGTCTTCGTCTTTGT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513320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g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G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GTGATTCGTAAGAGAATCCAA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9994380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G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CAAAAGTGTTTTCCCCAC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0458972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h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H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CAAAGCTCTCTTTGTTTTC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2884972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H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AGAACCCGTCTTCTTCCTT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6174995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8i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I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GTCAACAACACTCTCCCTCA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0812772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TG8I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ACCAAAGGTTTTCTCACTG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9303744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AS-A1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ASA1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ACGAGCGATTTTCTCCAT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8653985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ASA1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AATTCTCGAGGCCATGAT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2116171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AS-B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ASB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CTGCTTTCGATGTTTCCT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1656599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ASB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CACCAGCTTCTGGCTTGA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0049694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S-C1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ysC1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CACACCGTGAGGAAACTC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4035340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ysC1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CGTTGGTAGAGGGGAAGT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1996829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AS-C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ASC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AGGCAGAGTCGGAGTTTT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2877906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ASC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GTTGAGTCCATCAGGTCCA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430847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R1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R1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ATCTATGATGGGTCGTG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106300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R1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CCGTCTGTGGCTTGTAATC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6130294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R2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R2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ACCAAACTTGCCCATAGT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871971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R2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CTAATACAACCCTCCCAGCA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9165794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IR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AATGTTTGAAAAGGTTGGTCTGGAC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1882021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IR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CTCCTAGCCAAACCTGATAGCTGT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4296925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S1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DES1-F 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ACCATGGAAGACCGCGTCTTGA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1010272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DES1-R 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CATTCAACTGGCAAATTCTCAGCT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0236949"/>
                  </a:ext>
                </a:extLst>
              </a:tr>
              <a:tr h="21008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BIQUITIN</a:t>
                      </a:r>
                      <a:r>
                        <a:rPr lang="es-E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s-E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  <a:endParaRPr lang="es-ES" sz="10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UBQ10-F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GGCCTTGTATAATCCCTGATGAATAAG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502069"/>
                  </a:ext>
                </a:extLst>
              </a:tr>
              <a:tr h="21883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UBQ10-R</a:t>
                      </a:r>
                    </a:p>
                  </a:txBody>
                  <a:tcPr marL="7126" marR="7126" marT="7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s-E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AAGAGATAACAGGAACGGAAACATAGT</a:t>
                      </a:r>
                    </a:p>
                  </a:txBody>
                  <a:tcPr marL="7126" marR="7126" marT="7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86696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704943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173</Words>
  <Application>Microsoft Macintosh PowerPoint</Application>
  <PresentationFormat>A4 (210 x 297 mm)</PresentationFormat>
  <Paragraphs>9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ecilia Gotor Martínez</dc:creator>
  <cp:lastModifiedBy>Cecilia Gotor Martínez</cp:lastModifiedBy>
  <cp:revision>9</cp:revision>
  <dcterms:created xsi:type="dcterms:W3CDTF">2026-01-09T10:17:08Z</dcterms:created>
  <dcterms:modified xsi:type="dcterms:W3CDTF">2026-02-16T09:40:15Z</dcterms:modified>
</cp:coreProperties>
</file>